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61" r:id="rId2"/>
    <p:sldId id="270" r:id="rId3"/>
    <p:sldId id="266" r:id="rId4"/>
    <p:sldId id="288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437FF"/>
    <a:srgbClr val="FF66FF"/>
    <a:srgbClr val="FF99FF"/>
    <a:srgbClr val="FFCCCC"/>
    <a:srgbClr val="FF9900"/>
    <a:srgbClr val="FF6600"/>
    <a:srgbClr val="FF5050"/>
    <a:srgbClr val="FF9999"/>
    <a:srgbClr val="0000FF"/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197"/>
    <p:restoredTop sz="92245"/>
  </p:normalViewPr>
  <p:slideViewPr>
    <p:cSldViewPr snapToGrid="0" snapToObjects="1">
      <p:cViewPr varScale="1">
        <p:scale>
          <a:sx n="73" d="100"/>
          <a:sy n="73" d="100"/>
        </p:scale>
        <p:origin x="246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DC7089-C280-E340-B5CB-756B6097BC3D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AA2145-175F-1C44-9616-6621B335F6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6768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557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903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5391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720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9539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505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675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3650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29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4553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7175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481AE5-C58C-8846-8EE6-6B69C28F9BB7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1CA122-A8F7-EB41-B703-822EF90648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526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2F6AEA10-B0EC-78F0-1262-30943C29AF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388" t="14430" b="12891"/>
          <a:stretch/>
        </p:blipFill>
        <p:spPr>
          <a:xfrm>
            <a:off x="1352550" y="420920"/>
            <a:ext cx="3327701" cy="2101215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8970AFD2-B9B0-9F46-A62F-0FA505211AE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365" t="17021" b="12358"/>
          <a:stretch/>
        </p:blipFill>
        <p:spPr>
          <a:xfrm>
            <a:off x="1380336" y="3300674"/>
            <a:ext cx="3531530" cy="2142678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FA9A0CE-DBC9-D4EF-4185-BC9E432853FA}"/>
              </a:ext>
            </a:extLst>
          </p:cNvPr>
          <p:cNvSpPr txBox="1"/>
          <p:nvPr/>
        </p:nvSpPr>
        <p:spPr>
          <a:xfrm>
            <a:off x="624196" y="282420"/>
            <a:ext cx="1055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 (WT mice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6FF6605-44BA-EDE8-F526-5C6B0C843938}"/>
              </a:ext>
            </a:extLst>
          </p:cNvPr>
          <p:cNvSpPr txBox="1"/>
          <p:nvPr/>
        </p:nvSpPr>
        <p:spPr>
          <a:xfrm>
            <a:off x="624195" y="3040775"/>
            <a:ext cx="1459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 (PD-1 KO mice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5F4269A-D3DC-57FB-7CE2-22374445EF3D}"/>
              </a:ext>
            </a:extLst>
          </p:cNvPr>
          <p:cNvSpPr txBox="1"/>
          <p:nvPr/>
        </p:nvSpPr>
        <p:spPr>
          <a:xfrm>
            <a:off x="2025257" y="5582902"/>
            <a:ext cx="1743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ays after CS injection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8C84C17-611E-01F4-DEFC-E548962EE655}"/>
              </a:ext>
            </a:extLst>
          </p:cNvPr>
          <p:cNvSpPr txBox="1"/>
          <p:nvPr/>
        </p:nvSpPr>
        <p:spPr>
          <a:xfrm>
            <a:off x="1358057" y="5400443"/>
            <a:ext cx="1885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0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4F7B276-CF25-EE8D-B0E7-CE7384948870}"/>
              </a:ext>
            </a:extLst>
          </p:cNvPr>
          <p:cNvSpPr txBox="1"/>
          <p:nvPr/>
        </p:nvSpPr>
        <p:spPr>
          <a:xfrm>
            <a:off x="2084092" y="5400443"/>
            <a:ext cx="1885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5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2789C4F-6574-B197-CE4A-D620753C3EEA}"/>
              </a:ext>
            </a:extLst>
          </p:cNvPr>
          <p:cNvSpPr txBox="1"/>
          <p:nvPr/>
        </p:nvSpPr>
        <p:spPr>
          <a:xfrm>
            <a:off x="2747700" y="5400443"/>
            <a:ext cx="3696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0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66424A7-BAAE-B9E4-3107-96E1AB1DC347}"/>
              </a:ext>
            </a:extLst>
          </p:cNvPr>
          <p:cNvSpPr txBox="1"/>
          <p:nvPr/>
        </p:nvSpPr>
        <p:spPr>
          <a:xfrm>
            <a:off x="3471032" y="5400443"/>
            <a:ext cx="4229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5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C973881-0DC6-EC99-96D5-08680BF79845}"/>
              </a:ext>
            </a:extLst>
          </p:cNvPr>
          <p:cNvSpPr txBox="1"/>
          <p:nvPr/>
        </p:nvSpPr>
        <p:spPr>
          <a:xfrm>
            <a:off x="1192888" y="5231749"/>
            <a:ext cx="1885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0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9E5C576-7394-D9AA-AA3F-E960FD40822C}"/>
              </a:ext>
            </a:extLst>
          </p:cNvPr>
          <p:cNvSpPr txBox="1"/>
          <p:nvPr/>
        </p:nvSpPr>
        <p:spPr>
          <a:xfrm>
            <a:off x="1096472" y="4327867"/>
            <a:ext cx="372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50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83D8BEF-A012-3BE2-10DD-971FEC5A5644}"/>
              </a:ext>
            </a:extLst>
          </p:cNvPr>
          <p:cNvSpPr txBox="1"/>
          <p:nvPr/>
        </p:nvSpPr>
        <p:spPr>
          <a:xfrm rot="16200000">
            <a:off x="-15309" y="4327866"/>
            <a:ext cx="1951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Probability of survival (%)</a:t>
            </a:r>
            <a:endParaRPr kumimoji="1" lang="ja-JP" altLang="en-US" sz="12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4F1EF61-EE9C-40AD-AC9E-6A063BEB1301}"/>
              </a:ext>
            </a:extLst>
          </p:cNvPr>
          <p:cNvSpPr txBox="1"/>
          <p:nvPr/>
        </p:nvSpPr>
        <p:spPr>
          <a:xfrm>
            <a:off x="994363" y="3418301"/>
            <a:ext cx="4616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00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5F1C204-6EC1-31B9-5204-642695724598}"/>
              </a:ext>
            </a:extLst>
          </p:cNvPr>
          <p:cNvSpPr txBox="1"/>
          <p:nvPr/>
        </p:nvSpPr>
        <p:spPr>
          <a:xfrm>
            <a:off x="1966998" y="2690194"/>
            <a:ext cx="1743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ays after CS injection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78CE4D1-D126-91DF-F393-4597B653A940}"/>
              </a:ext>
            </a:extLst>
          </p:cNvPr>
          <p:cNvSpPr txBox="1"/>
          <p:nvPr/>
        </p:nvSpPr>
        <p:spPr>
          <a:xfrm>
            <a:off x="1299798" y="2507735"/>
            <a:ext cx="1885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0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35C612C-C26E-5720-2000-96773E921B6E}"/>
              </a:ext>
            </a:extLst>
          </p:cNvPr>
          <p:cNvSpPr txBox="1"/>
          <p:nvPr/>
        </p:nvSpPr>
        <p:spPr>
          <a:xfrm>
            <a:off x="2025833" y="2507735"/>
            <a:ext cx="1885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5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7745455-1C7A-45DC-7992-5D0BA37780FD}"/>
              </a:ext>
            </a:extLst>
          </p:cNvPr>
          <p:cNvSpPr txBox="1"/>
          <p:nvPr/>
        </p:nvSpPr>
        <p:spPr>
          <a:xfrm>
            <a:off x="2689441" y="2507735"/>
            <a:ext cx="3696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0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9999579-1685-AE6D-FF60-D232FE52D020}"/>
              </a:ext>
            </a:extLst>
          </p:cNvPr>
          <p:cNvSpPr txBox="1"/>
          <p:nvPr/>
        </p:nvSpPr>
        <p:spPr>
          <a:xfrm>
            <a:off x="3412773" y="2507735"/>
            <a:ext cx="4229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5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03663F7-8F7D-BB97-9FFA-8DC687648650}"/>
              </a:ext>
            </a:extLst>
          </p:cNvPr>
          <p:cNvSpPr txBox="1"/>
          <p:nvPr/>
        </p:nvSpPr>
        <p:spPr>
          <a:xfrm>
            <a:off x="1160580" y="2336118"/>
            <a:ext cx="1885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0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065AA4E-25ED-0867-E37B-14457E3ED206}"/>
              </a:ext>
            </a:extLst>
          </p:cNvPr>
          <p:cNvSpPr txBox="1"/>
          <p:nvPr/>
        </p:nvSpPr>
        <p:spPr>
          <a:xfrm>
            <a:off x="1064164" y="1432236"/>
            <a:ext cx="372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50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E101B121-D736-ECF7-BD86-4CAC9278DB4F}"/>
              </a:ext>
            </a:extLst>
          </p:cNvPr>
          <p:cNvSpPr txBox="1"/>
          <p:nvPr/>
        </p:nvSpPr>
        <p:spPr>
          <a:xfrm rot="16200000">
            <a:off x="-47617" y="1432235"/>
            <a:ext cx="1951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Probability of survival (%)</a:t>
            </a:r>
            <a:endParaRPr kumimoji="1" lang="ja-JP" altLang="en-US" sz="12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BB921B0-61A3-3163-8EE8-1F6A0429286B}"/>
              </a:ext>
            </a:extLst>
          </p:cNvPr>
          <p:cNvSpPr txBox="1"/>
          <p:nvPr/>
        </p:nvSpPr>
        <p:spPr>
          <a:xfrm>
            <a:off x="962055" y="522670"/>
            <a:ext cx="4616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00</a:t>
            </a:r>
            <a:endParaRPr kumimoji="1" lang="ja-JP" altLang="en-US" sz="12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7DA5D37-4B4E-420C-8160-F421CA30D9FA}"/>
              </a:ext>
            </a:extLst>
          </p:cNvPr>
          <p:cNvSpPr txBox="1"/>
          <p:nvPr/>
        </p:nvSpPr>
        <p:spPr>
          <a:xfrm>
            <a:off x="-2072" y="-1083"/>
            <a:ext cx="791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1896D19A-D631-4125-B46F-0206A39B6CC6}"/>
              </a:ext>
            </a:extLst>
          </p:cNvPr>
          <p:cNvSpPr/>
          <p:nvPr/>
        </p:nvSpPr>
        <p:spPr>
          <a:xfrm>
            <a:off x="107737" y="6476245"/>
            <a:ext cx="661007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1. Examination to determine the minimal lethal dose of CS in WT and PD-1 KO mice</a:t>
            </a:r>
            <a:r>
              <a:rPr lang="en-US" altLang="ja-JP" sz="1400" b="1" kern="0" dirty="0">
                <a:latin typeface="Arial" panose="020B0604020202020204" pitchFamily="34" charset="0"/>
                <a:ea typeface=".Hiragino Kaku Gothic Interfac"/>
                <a:cs typeface="Arial" panose="020B0604020202020204" pitchFamily="34" charset="0"/>
              </a:rPr>
              <a:t>. </a:t>
            </a:r>
            <a:r>
              <a:rPr lang="en-US" altLang="ja-JP" sz="1400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rvival probability in WT (A) and PD-1 KO (B) sepsis mice was analyzed by Kaplan–Meier analysis (WT mice, n = 3-5 per group; and PD-1 KO mice, n = 3-6 per group). 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29157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DF40DF0B-7AC6-EFFA-2C58-DD367BEC2A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226" y="781878"/>
            <a:ext cx="5951547" cy="3148369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DF3A6CB-CEF8-4D7F-9D8C-12C1AEED97A2}"/>
              </a:ext>
            </a:extLst>
          </p:cNvPr>
          <p:cNvSpPr txBox="1"/>
          <p:nvPr/>
        </p:nvSpPr>
        <p:spPr>
          <a:xfrm>
            <a:off x="-2072" y="-1083"/>
            <a:ext cx="791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A314D21-A0F2-40CC-84D9-29B55AC5A9B6}"/>
              </a:ext>
            </a:extLst>
          </p:cNvPr>
          <p:cNvSpPr/>
          <p:nvPr/>
        </p:nvSpPr>
        <p:spPr>
          <a:xfrm>
            <a:off x="393891" y="4854283"/>
            <a:ext cx="595154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</a:t>
            </a:r>
            <a:r>
              <a:rPr lang="en-US" altLang="ja-JP" sz="1400" b="1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S2. The flow cytometry gating strategy and representative dot plots to analyze the IL-13</a:t>
            </a:r>
            <a:r>
              <a:rPr lang="en-US" altLang="ja-JP" sz="1400" b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400" b="1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ells in ILC2s and CD3</a:t>
            </a:r>
            <a:r>
              <a:rPr lang="en-US" altLang="ja-JP" sz="1400" b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400" b="1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T cells</a:t>
            </a: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99993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40FAF20E-20C7-EFB4-0965-F58F38D5D9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2953" y="2754223"/>
            <a:ext cx="1437318" cy="1440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29D06C3F-EF58-00F6-A15B-01CC570ABC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5575" y="2754223"/>
            <a:ext cx="1445339" cy="14400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1723D1E3-66DD-C81C-EAA7-86228B36C9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43702" y="1042011"/>
            <a:ext cx="1445314" cy="14400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1B53A207-5A34-CF01-222D-B967CFBEE2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38705" y="1042011"/>
            <a:ext cx="1445363" cy="1440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65F1AA2-5CF9-0F71-C67F-7D7C5A1076CE}"/>
              </a:ext>
            </a:extLst>
          </p:cNvPr>
          <p:cNvSpPr txBox="1"/>
          <p:nvPr/>
        </p:nvSpPr>
        <p:spPr>
          <a:xfrm>
            <a:off x="1344469" y="816182"/>
            <a:ext cx="5373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0361C6C-7427-C005-3E86-33E025FD180C}"/>
              </a:ext>
            </a:extLst>
          </p:cNvPr>
          <p:cNvSpPr txBox="1"/>
          <p:nvPr/>
        </p:nvSpPr>
        <p:spPr>
          <a:xfrm>
            <a:off x="2919630" y="816182"/>
            <a:ext cx="5902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epsis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4D1FC786-7325-5906-F1F1-3A0EBD928218}"/>
              </a:ext>
            </a:extLst>
          </p:cNvPr>
          <p:cNvCxnSpPr>
            <a:cxnSpLocks/>
          </p:cNvCxnSpPr>
          <p:nvPr/>
        </p:nvCxnSpPr>
        <p:spPr>
          <a:xfrm>
            <a:off x="852048" y="2580234"/>
            <a:ext cx="2206981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67A6F1F-0AE5-E700-A035-436CABD10526}"/>
              </a:ext>
            </a:extLst>
          </p:cNvPr>
          <p:cNvSpPr txBox="1"/>
          <p:nvPr/>
        </p:nvSpPr>
        <p:spPr>
          <a:xfrm>
            <a:off x="231525" y="1683878"/>
            <a:ext cx="393057" cy="2539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WT</a:t>
            </a:r>
            <a:endParaRPr kumimoji="1" lang="ja-JP" altLang="en-US" sz="105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FECB0F5-FC5C-6DCA-26C1-4DECDDAF0269}"/>
              </a:ext>
            </a:extLst>
          </p:cNvPr>
          <p:cNvSpPr txBox="1"/>
          <p:nvPr/>
        </p:nvSpPr>
        <p:spPr>
          <a:xfrm>
            <a:off x="38954" y="3372363"/>
            <a:ext cx="748923" cy="2539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PD-1 KO</a:t>
            </a:r>
            <a:endParaRPr kumimoji="1" lang="ja-JP" altLang="en-US" sz="105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00D9FB57-FB71-8E8B-807F-3239F06C1C3E}"/>
              </a:ext>
            </a:extLst>
          </p:cNvPr>
          <p:cNvCxnSpPr>
            <a:cxnSpLocks/>
          </p:cNvCxnSpPr>
          <p:nvPr/>
        </p:nvCxnSpPr>
        <p:spPr>
          <a:xfrm flipV="1">
            <a:off x="878057" y="1939320"/>
            <a:ext cx="0" cy="640914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CDF61AB-FF05-6F16-7BF6-7432E03D58B9}"/>
              </a:ext>
            </a:extLst>
          </p:cNvPr>
          <p:cNvSpPr txBox="1"/>
          <p:nvPr/>
        </p:nvSpPr>
        <p:spPr>
          <a:xfrm rot="16200000">
            <a:off x="638958" y="1603189"/>
            <a:ext cx="4924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E41FD30-05C5-C582-822A-C38E36050D8E}"/>
              </a:ext>
            </a:extLst>
          </p:cNvPr>
          <p:cNvSpPr txBox="1"/>
          <p:nvPr/>
        </p:nvSpPr>
        <p:spPr>
          <a:xfrm>
            <a:off x="3077540" y="2436397"/>
            <a:ext cx="45397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ED0A3413-8DB0-73D1-2F90-C6C037D8399C}"/>
              </a:ext>
            </a:extLst>
          </p:cNvPr>
          <p:cNvCxnSpPr>
            <a:cxnSpLocks/>
          </p:cNvCxnSpPr>
          <p:nvPr/>
        </p:nvCxnSpPr>
        <p:spPr>
          <a:xfrm>
            <a:off x="860803" y="4267003"/>
            <a:ext cx="2206981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C332DAFB-549C-99A3-78A7-7F591ADC80D8}"/>
              </a:ext>
            </a:extLst>
          </p:cNvPr>
          <p:cNvCxnSpPr>
            <a:cxnSpLocks/>
          </p:cNvCxnSpPr>
          <p:nvPr/>
        </p:nvCxnSpPr>
        <p:spPr>
          <a:xfrm flipV="1">
            <a:off x="853682" y="3626089"/>
            <a:ext cx="0" cy="640914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E3713B3-C05A-413F-5D12-44288275D7DD}"/>
              </a:ext>
            </a:extLst>
          </p:cNvPr>
          <p:cNvSpPr txBox="1"/>
          <p:nvPr/>
        </p:nvSpPr>
        <p:spPr>
          <a:xfrm rot="16200000">
            <a:off x="628543" y="3289958"/>
            <a:ext cx="4924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5710F7D-6B28-BBA2-2816-4F4E9C3A7F8A}"/>
              </a:ext>
            </a:extLst>
          </p:cNvPr>
          <p:cNvSpPr txBox="1"/>
          <p:nvPr/>
        </p:nvSpPr>
        <p:spPr>
          <a:xfrm>
            <a:off x="3053165" y="4123166"/>
            <a:ext cx="45397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D8BED72-B61D-183B-DD4A-956D34A36101}"/>
              </a:ext>
            </a:extLst>
          </p:cNvPr>
          <p:cNvSpPr txBox="1"/>
          <p:nvPr/>
        </p:nvSpPr>
        <p:spPr>
          <a:xfrm>
            <a:off x="5211547" y="4212985"/>
            <a:ext cx="6187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epsis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269A743C-5399-E4E4-370A-D13F73BC1B72}"/>
              </a:ext>
            </a:extLst>
          </p:cNvPr>
          <p:cNvSpPr txBox="1"/>
          <p:nvPr/>
        </p:nvSpPr>
        <p:spPr>
          <a:xfrm>
            <a:off x="4777116" y="4212985"/>
            <a:ext cx="5353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386C2260-C57C-1E53-A748-7311268173D5}"/>
              </a:ext>
            </a:extLst>
          </p:cNvPr>
          <p:cNvCxnSpPr>
            <a:cxnSpLocks/>
          </p:cNvCxnSpPr>
          <p:nvPr/>
        </p:nvCxnSpPr>
        <p:spPr>
          <a:xfrm>
            <a:off x="4905481" y="4466901"/>
            <a:ext cx="79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E46C4C1-DB9D-F471-BB27-EA809BE60BE6}"/>
              </a:ext>
            </a:extLst>
          </p:cNvPr>
          <p:cNvSpPr txBox="1"/>
          <p:nvPr/>
        </p:nvSpPr>
        <p:spPr>
          <a:xfrm>
            <a:off x="4954692" y="4466901"/>
            <a:ext cx="7155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D-1KO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C08C769-669B-0E85-DD12-7AF964983450}"/>
              </a:ext>
            </a:extLst>
          </p:cNvPr>
          <p:cNvSpPr txBox="1"/>
          <p:nvPr/>
        </p:nvSpPr>
        <p:spPr>
          <a:xfrm>
            <a:off x="417805" y="653107"/>
            <a:ext cx="1761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9D07C1D-422B-F42C-CFC5-4F4DE00BEBD1}"/>
              </a:ext>
            </a:extLst>
          </p:cNvPr>
          <p:cNvSpPr txBox="1"/>
          <p:nvPr/>
        </p:nvSpPr>
        <p:spPr>
          <a:xfrm>
            <a:off x="4293923" y="2253472"/>
            <a:ext cx="1761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520BE2C4-B307-3FCD-46EA-A95641DE99C1}"/>
              </a:ext>
            </a:extLst>
          </p:cNvPr>
          <p:cNvSpPr/>
          <p:nvPr/>
        </p:nvSpPr>
        <p:spPr>
          <a:xfrm>
            <a:off x="2057748" y="1070098"/>
            <a:ext cx="293166" cy="3428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highlight>
                <a:srgbClr val="FFFF00"/>
              </a:highlight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F939A4AF-44EF-C419-5E4E-45BA87D633A8}"/>
              </a:ext>
            </a:extLst>
          </p:cNvPr>
          <p:cNvSpPr/>
          <p:nvPr/>
        </p:nvSpPr>
        <p:spPr>
          <a:xfrm>
            <a:off x="3552853" y="1125621"/>
            <a:ext cx="293166" cy="3428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highlight>
                <a:srgbClr val="FFFF00"/>
              </a:highlight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6B33AD30-46B4-361E-3228-A3691AAB2E1D}"/>
              </a:ext>
            </a:extLst>
          </p:cNvPr>
          <p:cNvSpPr/>
          <p:nvPr/>
        </p:nvSpPr>
        <p:spPr>
          <a:xfrm>
            <a:off x="3580852" y="2801584"/>
            <a:ext cx="293166" cy="3428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highlight>
                <a:srgbClr val="FFFF00"/>
              </a:highlight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0AD4313A-3248-1A7C-604E-0BCDB9F402AE}"/>
              </a:ext>
            </a:extLst>
          </p:cNvPr>
          <p:cNvSpPr/>
          <p:nvPr/>
        </p:nvSpPr>
        <p:spPr>
          <a:xfrm>
            <a:off x="2014358" y="2807057"/>
            <a:ext cx="293166" cy="3428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highlight>
                <a:srgbClr val="FFFF00"/>
              </a:highlight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3896399C-0813-C3DA-855B-8D9BEF9FD8F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3280" t="17438" r="17386" b="14124"/>
          <a:stretch/>
        </p:blipFill>
        <p:spPr>
          <a:xfrm>
            <a:off x="4677347" y="2588472"/>
            <a:ext cx="1178803" cy="1686769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4FBB6AA-5964-F61A-71A0-BD1ADECCE965}"/>
              </a:ext>
            </a:extLst>
          </p:cNvPr>
          <p:cNvSpPr txBox="1"/>
          <p:nvPr/>
        </p:nvSpPr>
        <p:spPr>
          <a:xfrm rot="16200000">
            <a:off x="3863677" y="3304898"/>
            <a:ext cx="11144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kumimoji="1" lang="en-US" altLang="ja-JP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ILC2 (%)</a:t>
            </a:r>
            <a:endParaRPr kumimoji="1" lang="ja-JP" altLang="en-US" sz="1050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5C56062-4A4D-4F19-453F-DECFCEE0B48C}"/>
              </a:ext>
            </a:extLst>
          </p:cNvPr>
          <p:cNvSpPr txBox="1"/>
          <p:nvPr/>
        </p:nvSpPr>
        <p:spPr>
          <a:xfrm>
            <a:off x="4474224" y="4053146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7964540-51A1-FE94-D726-4E9D837C2265}"/>
              </a:ext>
            </a:extLst>
          </p:cNvPr>
          <p:cNvSpPr txBox="1"/>
          <p:nvPr/>
        </p:nvSpPr>
        <p:spPr>
          <a:xfrm>
            <a:off x="4474224" y="3555052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1FEEE91-166C-C639-0369-884A359364E5}"/>
              </a:ext>
            </a:extLst>
          </p:cNvPr>
          <p:cNvSpPr txBox="1"/>
          <p:nvPr/>
        </p:nvSpPr>
        <p:spPr>
          <a:xfrm>
            <a:off x="4398884" y="302851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03E2514-0BEC-3DCA-1842-A4055B1FE008}"/>
              </a:ext>
            </a:extLst>
          </p:cNvPr>
          <p:cNvSpPr txBox="1"/>
          <p:nvPr/>
        </p:nvSpPr>
        <p:spPr>
          <a:xfrm>
            <a:off x="4415360" y="2539430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04DCE24C-565D-430F-AE9B-42B17330EBB4}"/>
              </a:ext>
            </a:extLst>
          </p:cNvPr>
          <p:cNvSpPr txBox="1"/>
          <p:nvPr/>
        </p:nvSpPr>
        <p:spPr>
          <a:xfrm>
            <a:off x="-2072" y="-1083"/>
            <a:ext cx="791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95F5F0F6-0422-4B09-B0CC-48410C7F5E2B}"/>
              </a:ext>
            </a:extLst>
          </p:cNvPr>
          <p:cNvSpPr/>
          <p:nvPr/>
        </p:nvSpPr>
        <p:spPr>
          <a:xfrm>
            <a:off x="220508" y="5469566"/>
            <a:ext cx="640239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</a:t>
            </a:r>
            <a:r>
              <a:rPr lang="en-US" altLang="ja-JP" sz="1400" b="1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S3. Comparison of PD-1</a:t>
            </a:r>
            <a:r>
              <a:rPr lang="en-US" altLang="ja-JP" sz="1400" b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400" b="1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ell population between sham and sepsis of WT and PD-1 KO mice. </a:t>
            </a: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 The representative dot plots are shown to analyze the PD-1</a:t>
            </a:r>
            <a:r>
              <a:rPr lang="en-US" altLang="ja-JP" sz="1400" kern="0" baseline="300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ells in skeletal muscle of WT (upper) and PD-1 KO (lower) mice. (B) The percentages of PD-1</a:t>
            </a:r>
            <a:r>
              <a:rPr lang="en-US" altLang="ja-JP" sz="1400" kern="0" baseline="300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LC2s in skeletal muscle of PD-1 KO mice in the condition of sham and sepsis (n = 4 per group)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ta represent the mean ± SEM.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17512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20AF954-692D-DA05-2DAF-DED2B1B02DA4}"/>
              </a:ext>
            </a:extLst>
          </p:cNvPr>
          <p:cNvSpPr txBox="1"/>
          <p:nvPr/>
        </p:nvSpPr>
        <p:spPr>
          <a:xfrm>
            <a:off x="1994855" y="2667639"/>
            <a:ext cx="3930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130220F-9787-F7B4-2797-8D95BA87F3E9}"/>
              </a:ext>
            </a:extLst>
          </p:cNvPr>
          <p:cNvSpPr txBox="1"/>
          <p:nvPr/>
        </p:nvSpPr>
        <p:spPr>
          <a:xfrm>
            <a:off x="2328285" y="2667639"/>
            <a:ext cx="7232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D-1 KO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C40C1A9-96D8-93BA-9BEF-4D37C81AA715}"/>
              </a:ext>
            </a:extLst>
          </p:cNvPr>
          <p:cNvSpPr txBox="1"/>
          <p:nvPr/>
        </p:nvSpPr>
        <p:spPr>
          <a:xfrm>
            <a:off x="2197799" y="2896729"/>
            <a:ext cx="5373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7C516B15-ADE9-844A-7567-68577E214BAB}"/>
              </a:ext>
            </a:extLst>
          </p:cNvPr>
          <p:cNvCxnSpPr>
            <a:cxnSpLocks/>
          </p:cNvCxnSpPr>
          <p:nvPr/>
        </p:nvCxnSpPr>
        <p:spPr>
          <a:xfrm>
            <a:off x="2002437" y="2923565"/>
            <a:ext cx="9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A2158CF-3824-192C-23F0-7A729F24C1D0}"/>
              </a:ext>
            </a:extLst>
          </p:cNvPr>
          <p:cNvSpPr txBox="1"/>
          <p:nvPr/>
        </p:nvSpPr>
        <p:spPr>
          <a:xfrm rot="16200000">
            <a:off x="746110" y="1652559"/>
            <a:ext cx="15648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L-13</a:t>
            </a:r>
            <a:r>
              <a:rPr kumimoji="1" lang="en-US" altLang="ja-JP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cells in ILC2 (%)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058919C-8533-1701-CEFD-7A1F87F97A02}"/>
              </a:ext>
            </a:extLst>
          </p:cNvPr>
          <p:cNvSpPr txBox="1"/>
          <p:nvPr/>
        </p:nvSpPr>
        <p:spPr>
          <a:xfrm>
            <a:off x="1613759" y="2518333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AA89EE8-DDDF-50A6-18B8-D116F7D5E338}"/>
              </a:ext>
            </a:extLst>
          </p:cNvPr>
          <p:cNvSpPr txBox="1"/>
          <p:nvPr/>
        </p:nvSpPr>
        <p:spPr>
          <a:xfrm>
            <a:off x="1552758" y="199391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96DEEE4-C45F-F1A2-DC2D-D0CE4753F897}"/>
              </a:ext>
            </a:extLst>
          </p:cNvPr>
          <p:cNvSpPr txBox="1"/>
          <p:nvPr/>
        </p:nvSpPr>
        <p:spPr>
          <a:xfrm>
            <a:off x="1546043" y="1462872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5B894E2-1834-97B2-2981-DC8CADBDC934}"/>
              </a:ext>
            </a:extLst>
          </p:cNvPr>
          <p:cNvSpPr txBox="1"/>
          <p:nvPr/>
        </p:nvSpPr>
        <p:spPr>
          <a:xfrm>
            <a:off x="1552758" y="91986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821B2EB2-D107-E2B4-DB97-FEFE1F243E5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281" t="16827" r="29687" b="27015"/>
          <a:stretch/>
        </p:blipFill>
        <p:spPr>
          <a:xfrm>
            <a:off x="1799959" y="904788"/>
            <a:ext cx="1296920" cy="1877189"/>
          </a:xfrm>
          <a:prstGeom prst="rect">
            <a:avLst/>
          </a:prstGeom>
        </p:spPr>
      </p:pic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B100D4E2-6784-54DB-15BE-07D3A994E4F2}"/>
              </a:ext>
            </a:extLst>
          </p:cNvPr>
          <p:cNvCxnSpPr>
            <a:cxnSpLocks/>
          </p:cNvCxnSpPr>
          <p:nvPr/>
        </p:nvCxnSpPr>
        <p:spPr>
          <a:xfrm>
            <a:off x="2116771" y="1189023"/>
            <a:ext cx="64480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8ABFECE-8841-D975-D53A-D19BC9EDF58C}"/>
              </a:ext>
            </a:extLst>
          </p:cNvPr>
          <p:cNvSpPr txBox="1"/>
          <p:nvPr/>
        </p:nvSpPr>
        <p:spPr>
          <a:xfrm>
            <a:off x="2070334" y="962504"/>
            <a:ext cx="792255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0504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44D81A23-2641-EA99-3452-9A1043C1779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157" t="13913" r="26752" b="32040"/>
          <a:stretch/>
        </p:blipFill>
        <p:spPr>
          <a:xfrm>
            <a:off x="3307190" y="3526948"/>
            <a:ext cx="1349205" cy="200037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BBAE1DDB-6FE2-22D0-DC06-DAE58A3501D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785" t="12829" r="25151" b="32722"/>
          <a:stretch/>
        </p:blipFill>
        <p:spPr>
          <a:xfrm>
            <a:off x="1839436" y="3504762"/>
            <a:ext cx="1349205" cy="2014796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D135666-29B5-942A-2584-691F32323E8A}"/>
              </a:ext>
            </a:extLst>
          </p:cNvPr>
          <p:cNvSpPr txBox="1"/>
          <p:nvPr/>
        </p:nvSpPr>
        <p:spPr>
          <a:xfrm rot="16200000">
            <a:off x="335406" y="4314124"/>
            <a:ext cx="224928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hange in ILC2-derived IL-13 (Fold change)</a:t>
            </a:r>
            <a:endParaRPr kumimoji="1" lang="ja-JP" altLang="en-US" sz="105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41247CB3-91E1-CC4B-F56F-648D0A9B5208}"/>
              </a:ext>
            </a:extLst>
          </p:cNvPr>
          <p:cNvSpPr txBox="1"/>
          <p:nvPr/>
        </p:nvSpPr>
        <p:spPr>
          <a:xfrm>
            <a:off x="1627019" y="5325771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861FC284-7631-04AE-A108-093BBA738FFD}"/>
              </a:ext>
            </a:extLst>
          </p:cNvPr>
          <p:cNvSpPr txBox="1"/>
          <p:nvPr/>
        </p:nvSpPr>
        <p:spPr>
          <a:xfrm>
            <a:off x="1547583" y="4723538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22670227-691B-3543-8175-5983B5071995}"/>
              </a:ext>
            </a:extLst>
          </p:cNvPr>
          <p:cNvSpPr txBox="1"/>
          <p:nvPr/>
        </p:nvSpPr>
        <p:spPr>
          <a:xfrm>
            <a:off x="1540868" y="4143852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D9ACCBD5-3DA9-55AD-91FB-BBAC1DD19FFB}"/>
              </a:ext>
            </a:extLst>
          </p:cNvPr>
          <p:cNvSpPr txBox="1"/>
          <p:nvPr/>
        </p:nvSpPr>
        <p:spPr>
          <a:xfrm>
            <a:off x="1547583" y="353274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AB140D46-3E34-27B1-A9DE-C68FAFAE331B}"/>
              </a:ext>
            </a:extLst>
          </p:cNvPr>
          <p:cNvGrpSpPr>
            <a:grpSpLocks noChangeAspect="1"/>
          </p:cNvGrpSpPr>
          <p:nvPr/>
        </p:nvGrpSpPr>
        <p:grpSpPr>
          <a:xfrm>
            <a:off x="3362628" y="5601354"/>
            <a:ext cx="180000" cy="342653"/>
            <a:chOff x="7415592" y="3485777"/>
            <a:chExt cx="400148" cy="416951"/>
          </a:xfrm>
        </p:grpSpPr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1112C79E-5DEB-C695-3223-4B74976206DA}"/>
                </a:ext>
              </a:extLst>
            </p:cNvPr>
            <p:cNvSpPr/>
            <p:nvPr/>
          </p:nvSpPr>
          <p:spPr>
            <a:xfrm>
              <a:off x="7415592" y="3735583"/>
              <a:ext cx="400148" cy="16714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7B6317DB-76E1-23DD-A683-2B208259B6B5}"/>
                </a:ext>
              </a:extLst>
            </p:cNvPr>
            <p:cNvSpPr/>
            <p:nvPr/>
          </p:nvSpPr>
          <p:spPr>
            <a:xfrm>
              <a:off x="7415592" y="3485777"/>
              <a:ext cx="400148" cy="167145"/>
            </a:xfrm>
            <a:prstGeom prst="rect">
              <a:avLst/>
            </a:prstGeom>
            <a:pattFill prst="wdUp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95667CC9-B745-B721-3EBD-1B8B3C7C3595}"/>
              </a:ext>
            </a:extLst>
          </p:cNvPr>
          <p:cNvGrpSpPr>
            <a:grpSpLocks noChangeAspect="1"/>
          </p:cNvGrpSpPr>
          <p:nvPr/>
        </p:nvGrpSpPr>
        <p:grpSpPr>
          <a:xfrm>
            <a:off x="1863826" y="5625819"/>
            <a:ext cx="180000" cy="333308"/>
            <a:chOff x="7293424" y="1390318"/>
            <a:chExt cx="400148" cy="416951"/>
          </a:xfrm>
        </p:grpSpPr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64E2969E-2E7F-1A72-C697-CE7D2ED36A3F}"/>
                </a:ext>
              </a:extLst>
            </p:cNvPr>
            <p:cNvSpPr/>
            <p:nvPr/>
          </p:nvSpPr>
          <p:spPr>
            <a:xfrm>
              <a:off x="7293424" y="1640124"/>
              <a:ext cx="400148" cy="167145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233FC7A4-283D-8CBC-EB22-86C9765AA256}"/>
                </a:ext>
              </a:extLst>
            </p:cNvPr>
            <p:cNvSpPr/>
            <p:nvPr/>
          </p:nvSpPr>
          <p:spPr>
            <a:xfrm>
              <a:off x="7293424" y="1390318"/>
              <a:ext cx="400148" cy="16714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6BAECD33-C0F3-7D6F-FA30-7A3BDB368BDE}"/>
              </a:ext>
            </a:extLst>
          </p:cNvPr>
          <p:cNvSpPr txBox="1"/>
          <p:nvPr/>
        </p:nvSpPr>
        <p:spPr>
          <a:xfrm>
            <a:off x="1997359" y="5559559"/>
            <a:ext cx="120332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WT mice (sham)</a:t>
            </a:r>
            <a:endParaRPr kumimoji="1" lang="ja-JP" altLang="en-US" sz="105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0DE8BFB8-607A-6586-5A1E-FC1A422520E4}"/>
              </a:ext>
            </a:extLst>
          </p:cNvPr>
          <p:cNvSpPr txBox="1"/>
          <p:nvPr/>
        </p:nvSpPr>
        <p:spPr>
          <a:xfrm>
            <a:off x="1997359" y="5775594"/>
            <a:ext cx="12982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WT mice (sepsis)</a:t>
            </a:r>
            <a:endParaRPr kumimoji="1" lang="ja-JP" altLang="en-US" sz="105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706E1329-4249-EC7B-5CA1-EBA776329E87}"/>
              </a:ext>
            </a:extLst>
          </p:cNvPr>
          <p:cNvSpPr txBox="1"/>
          <p:nvPr/>
        </p:nvSpPr>
        <p:spPr>
          <a:xfrm>
            <a:off x="3496161" y="5750847"/>
            <a:ext cx="15505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PD-1 KO mice (sepsis)</a:t>
            </a:r>
            <a:endParaRPr kumimoji="1" lang="ja-JP" altLang="en-US" sz="105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FFDC60CC-01DD-7B5D-E3F9-AF95BD66932B}"/>
              </a:ext>
            </a:extLst>
          </p:cNvPr>
          <p:cNvSpPr txBox="1"/>
          <p:nvPr/>
        </p:nvSpPr>
        <p:spPr>
          <a:xfrm>
            <a:off x="3496161" y="5545906"/>
            <a:ext cx="15505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PD-1 KO mice (sham)</a:t>
            </a:r>
            <a:endParaRPr kumimoji="1" lang="ja-JP" altLang="en-US" sz="105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C7CE2EA-CC89-443C-B296-288C05BC503E}"/>
              </a:ext>
            </a:extLst>
          </p:cNvPr>
          <p:cNvSpPr txBox="1"/>
          <p:nvPr/>
        </p:nvSpPr>
        <p:spPr>
          <a:xfrm>
            <a:off x="-2072" y="-1083"/>
            <a:ext cx="7919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A9989A6-A5CA-61B7-05DC-86C8B627796A}"/>
              </a:ext>
            </a:extLst>
          </p:cNvPr>
          <p:cNvSpPr txBox="1"/>
          <p:nvPr/>
        </p:nvSpPr>
        <p:spPr>
          <a:xfrm>
            <a:off x="1331130" y="639901"/>
            <a:ext cx="1761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3ECA7C4-F0FE-74ED-BC2D-D97B118C3BB4}"/>
              </a:ext>
            </a:extLst>
          </p:cNvPr>
          <p:cNvSpPr txBox="1"/>
          <p:nvPr/>
        </p:nvSpPr>
        <p:spPr>
          <a:xfrm>
            <a:off x="1179407" y="3377804"/>
            <a:ext cx="1761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92F27CF4-22A8-DA40-9B2B-1C4562C56286}"/>
              </a:ext>
            </a:extLst>
          </p:cNvPr>
          <p:cNvSpPr/>
          <p:nvPr/>
        </p:nvSpPr>
        <p:spPr>
          <a:xfrm>
            <a:off x="186021" y="6456433"/>
            <a:ext cx="6533214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</a:t>
            </a:r>
            <a:r>
              <a:rPr lang="en-US" altLang="ja-JP" sz="1400" b="1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S4. </a:t>
            </a:r>
            <a:r>
              <a:rPr lang="en-US" altLang="ja-JP" sz="1400" b="1" kern="0" dirty="0">
                <a:effectLst/>
                <a:latin typeface="Arial" panose="020B0604020202020204" pitchFamily="34" charset="0"/>
                <a:ea typeface=".Hiragino Kaku Gothic Interfac"/>
                <a:cs typeface="Arial" panose="020B0604020202020204" pitchFamily="34" charset="0"/>
              </a:rPr>
              <a:t>Production of muscle ILC2-derived IL-13 in WT and PD-1 mice. </a:t>
            </a:r>
            <a:endParaRPr lang="en-US" altLang="ja-JP" sz="1400" b="1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ja-JP" sz="1400" kern="0" dirty="0">
                <a:effectLst/>
                <a:latin typeface="Arial" panose="020B0604020202020204" pitchFamily="34" charset="0"/>
                <a:ea typeface=".Hiragino Kaku Gothic Interfac"/>
                <a:cs typeface="Arial" panose="020B0604020202020204" pitchFamily="34" charset="0"/>
              </a:rPr>
              <a:t>(A) The percentages of IL-13</a:t>
            </a:r>
            <a:r>
              <a:rPr lang="en-US" altLang="ja-JP" sz="1400" kern="0" baseline="30000" dirty="0">
                <a:effectLst/>
                <a:latin typeface="Arial" panose="020B0604020202020204" pitchFamily="34" charset="0"/>
                <a:ea typeface=".Hiragino Kaku Gothic Interfac"/>
                <a:cs typeface="Arial" panose="020B0604020202020204" pitchFamily="34" charset="0"/>
              </a:rPr>
              <a:t>+</a:t>
            </a:r>
            <a:r>
              <a:rPr lang="en-US" altLang="ja-JP" sz="1400" kern="0" dirty="0">
                <a:effectLst/>
                <a:latin typeface="Arial" panose="020B0604020202020204" pitchFamily="34" charset="0"/>
                <a:ea typeface=".Hiragino Kaku Gothic Interfac"/>
                <a:cs typeface="Arial" panose="020B0604020202020204" pitchFamily="34" charset="0"/>
              </a:rPr>
              <a:t> cells in ILC2s in skeletal muscle under normal conditions. (B) Change in the expression ILC2-derived IL-13 of WT (</a:t>
            </a:r>
            <a:r>
              <a:rPr lang="en-US" altLang="ja-JP" sz="1400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 = 3-4 per group</a:t>
            </a:r>
            <a:r>
              <a:rPr lang="en-US" altLang="ja-JP" sz="1400" kern="0" dirty="0">
                <a:effectLst/>
                <a:latin typeface="Arial" panose="020B0604020202020204" pitchFamily="34" charset="0"/>
                <a:ea typeface=".Hiragino Kaku Gothic Interfac"/>
                <a:cs typeface="Arial" panose="020B0604020202020204" pitchFamily="34" charset="0"/>
              </a:rPr>
              <a:t>) and PD-1 KO (</a:t>
            </a:r>
            <a:r>
              <a:rPr lang="en-US" altLang="ja-JP" sz="1400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 = 3-4 per group</a:t>
            </a:r>
            <a:r>
              <a:rPr lang="en-US" altLang="ja-JP" sz="1400" kern="0" dirty="0">
                <a:effectLst/>
                <a:latin typeface="Arial" panose="020B0604020202020204" pitchFamily="34" charset="0"/>
                <a:ea typeface=".Hiragino Kaku Gothic Interfac"/>
                <a:cs typeface="Arial" panose="020B0604020202020204" pitchFamily="34" charset="0"/>
              </a:rPr>
              <a:t>) mice.</a:t>
            </a:r>
            <a:r>
              <a:rPr lang="en-US" altLang="ja-JP" sz="1400" i="1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P</a:t>
            </a:r>
            <a:r>
              <a:rPr lang="en-US" altLang="ja-JP" sz="14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value</a:t>
            </a:r>
            <a:r>
              <a:rPr lang="ja-JP" altLang="en-US" sz="1400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0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</a:t>
            </a:r>
            <a:r>
              <a:rPr lang="en-US" altLang="ja-JP" sz="14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was determined by a Student’s </a:t>
            </a:r>
            <a:r>
              <a:rPr lang="en-US" altLang="ja-JP" sz="1400" i="1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</a:t>
            </a:r>
            <a:r>
              <a:rPr lang="en-US" altLang="ja-JP" sz="14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test</a:t>
            </a:r>
            <a:r>
              <a:rPr lang="en-US" altLang="ja-JP" sz="1400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ta represent the mean ± SEM</a:t>
            </a:r>
            <a:r>
              <a:rPr lang="en-US" altLang="ja-JP" sz="1400" b="1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5868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77</TotalTime>
  <Words>379</Words>
  <Application>Microsoft Office PowerPoint</Application>
  <PresentationFormat>A4 210 x 297 mm</PresentationFormat>
  <Paragraphs>67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3" baseType="lpstr">
      <vt:lpstr>.Hiragino Kaku Gothic Interfac</vt:lpstr>
      <vt:lpstr>Meiryo</vt:lpstr>
      <vt:lpstr>游ゴシック</vt:lpstr>
      <vt:lpstr>游ゴシック Light</vt:lpstr>
      <vt:lpstr>游明朝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赤間悠一</dc:creator>
  <cp:lastModifiedBy>Eun Jeong Park</cp:lastModifiedBy>
  <cp:revision>277</cp:revision>
  <dcterms:created xsi:type="dcterms:W3CDTF">2019-09-12T02:51:13Z</dcterms:created>
  <dcterms:modified xsi:type="dcterms:W3CDTF">2024-06-10T05:46:37Z</dcterms:modified>
</cp:coreProperties>
</file>